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  <p:sldId id="258" r:id="rId6"/>
    <p:sldId id="259" r:id="rId7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F2E88-2BF2-46F5-A8B8-D09123F2F8F4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213FF-75B2-4ED8-9DA6-13454B824B6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3471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F2E88-2BF2-46F5-A8B8-D09123F2F8F4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213FF-75B2-4ED8-9DA6-13454B824B6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83084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F2E88-2BF2-46F5-A8B8-D09123F2F8F4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213FF-75B2-4ED8-9DA6-13454B824B6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78335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F2E88-2BF2-46F5-A8B8-D09123F2F8F4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213FF-75B2-4ED8-9DA6-13454B824B6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788372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F2E88-2BF2-46F5-A8B8-D09123F2F8F4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213FF-75B2-4ED8-9DA6-13454B824B6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51005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F2E88-2BF2-46F5-A8B8-D09123F2F8F4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213FF-75B2-4ED8-9DA6-13454B824B6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498090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F2E88-2BF2-46F5-A8B8-D09123F2F8F4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213FF-75B2-4ED8-9DA6-13454B824B6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48891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F2E88-2BF2-46F5-A8B8-D09123F2F8F4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213FF-75B2-4ED8-9DA6-13454B824B6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661784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F2E88-2BF2-46F5-A8B8-D09123F2F8F4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213FF-75B2-4ED8-9DA6-13454B824B6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393798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F2E88-2BF2-46F5-A8B8-D09123F2F8F4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213FF-75B2-4ED8-9DA6-13454B824B6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525520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F2E88-2BF2-46F5-A8B8-D09123F2F8F4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B213FF-75B2-4ED8-9DA6-13454B824B6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42810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CF2E88-2BF2-46F5-A8B8-D09123F2F8F4}" type="datetimeFigureOut">
              <a:rPr lang="it-IT" smtClean="0"/>
              <a:t>02/03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B213FF-75B2-4ED8-9DA6-13454B824B6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48287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media" Target="../media/media2.avi"/><Relationship Id="rId7" Type="http://schemas.openxmlformats.org/officeDocument/2006/relationships/image" Target="../media/image2.png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2.avi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media" Target="../media/media4.avi"/><Relationship Id="rId7" Type="http://schemas.openxmlformats.org/officeDocument/2006/relationships/image" Target="../media/image4.png"/><Relationship Id="rId2" Type="http://schemas.openxmlformats.org/officeDocument/2006/relationships/video" Target="../media/media3.avi"/><Relationship Id="rId1" Type="http://schemas.microsoft.com/office/2007/relationships/media" Target="../media/media3.avi"/><Relationship Id="rId6" Type="http://schemas.openxmlformats.org/officeDocument/2006/relationships/image" Target="../media/image3.pn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4.avi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D3127389-B735-4A4C-B66A-78AAAF3161FB}"/>
              </a:ext>
            </a:extLst>
          </p:cNvPr>
          <p:cNvSpPr txBox="1"/>
          <p:nvPr/>
        </p:nvSpPr>
        <p:spPr>
          <a:xfrm>
            <a:off x="-62753" y="4686251"/>
            <a:ext cx="1219199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it-IT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vies </a:t>
            </a:r>
          </a:p>
          <a:p>
            <a:pPr algn="ctr"/>
            <a:r>
              <a:rPr lang="it-IT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igure 5)</a:t>
            </a:r>
            <a:endParaRPr lang="it-IT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E8C6C436-16E9-2245-8684-BAB4AE11FE90}"/>
              </a:ext>
            </a:extLst>
          </p:cNvPr>
          <p:cNvSpPr txBox="1"/>
          <p:nvPr/>
        </p:nvSpPr>
        <p:spPr>
          <a:xfrm>
            <a:off x="1241610" y="370839"/>
            <a:ext cx="9583271" cy="37856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4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TUNNELING NANOTUBES CONNECT BLOOD-BRAIN BARRIER CELLS: ROLE OF PERICYTES IN BARRIER PRESERVATION DURING ISCHEMIA</a:t>
            </a:r>
          </a:p>
          <a:p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it-IT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rancesco Pisani</a:t>
            </a:r>
            <a:r>
              <a:rPr lang="it-IT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,2</a:t>
            </a:r>
            <a:r>
              <a:rPr lang="it-IT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*,</a:t>
            </a:r>
            <a:r>
              <a:rPr lang="it-IT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Valentina Castagnola</a:t>
            </a:r>
            <a:r>
              <a:rPr lang="it-IT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,3</a:t>
            </a:r>
            <a:r>
              <a:rPr lang="it-IT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*, Laura Simone</a:t>
            </a:r>
            <a:r>
              <a:rPr lang="it-IT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4</a:t>
            </a:r>
            <a:r>
              <a:rPr lang="it-IT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Fabrizio Loiacono</a:t>
            </a:r>
            <a:r>
              <a:rPr lang="it-IT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3</a:t>
            </a:r>
            <a:r>
              <a:rPr lang="it-IT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Maria Svelto</a:t>
            </a:r>
            <a:r>
              <a:rPr lang="it-IT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,5</a:t>
            </a:r>
            <a:r>
              <a:rPr lang="it-IT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Fabio Benfenati</a:t>
            </a:r>
            <a:r>
              <a:rPr lang="it-IT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,3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it-IT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</a:p>
          <a:p>
            <a:r>
              <a:rPr lang="en-US" sz="16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1</a:t>
            </a:r>
            <a:r>
              <a:rPr lang="en-US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epartment of Biosciences, Biotechnologies and Biopharmaceutics, University of Bari “Aldo Moro”, Bari, Italy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it-IT" sz="16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it-IT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enter for </a:t>
            </a:r>
            <a:r>
              <a:rPr lang="it-IT" sz="16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ynaptic</a:t>
            </a:r>
            <a:r>
              <a:rPr lang="it-IT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6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euroscience</a:t>
            </a:r>
            <a:r>
              <a:rPr lang="it-IT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Technology, Istituto Italiano di Tecnologia, Genova, </a:t>
            </a:r>
            <a:r>
              <a:rPr lang="it-IT" sz="16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taly</a:t>
            </a:r>
            <a:r>
              <a:rPr lang="it-IT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it-IT" sz="16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3</a:t>
            </a:r>
            <a:r>
              <a:rPr lang="it-IT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RCCS Ospedale Policlinico San Martino, Genova, </a:t>
            </a:r>
            <a:r>
              <a:rPr lang="it-IT" sz="16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taly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it-IT" sz="16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4</a:t>
            </a:r>
            <a:r>
              <a:rPr lang="it-IT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ndazione IRCCS Casa Sollievo della Sofferenza, </a:t>
            </a:r>
            <a:r>
              <a:rPr lang="it-IT" sz="16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ancer</a:t>
            </a:r>
            <a:r>
              <a:rPr lang="it-IT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6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tem</a:t>
            </a:r>
            <a:r>
              <a:rPr lang="it-IT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6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ells</a:t>
            </a:r>
            <a:r>
              <a:rPr lang="it-IT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Unit, San Giovanni Rotondo, </a:t>
            </a:r>
            <a:r>
              <a:rPr lang="it-IT" sz="16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taly</a:t>
            </a:r>
            <a:r>
              <a:rPr lang="it-IT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US" sz="16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5</a:t>
            </a:r>
            <a:r>
              <a:rPr lang="en-US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stitute of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iomembranes</a:t>
            </a:r>
            <a:r>
              <a:rPr lang="en-US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Bioenergetics, National Research Council, Bari, Italy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nd National Institute of Biostructures and Biosystems, Rome, </a:t>
            </a:r>
            <a:r>
              <a:rPr lang="en-US" sz="1600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taly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74465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>
            <a:extLst>
              <a:ext uri="{FF2B5EF4-FFF2-40B4-BE49-F238E27FC236}">
                <a16:creationId xmlns:a16="http://schemas.microsoft.com/office/drawing/2014/main" id="{AEC54BB6-1449-954D-96DA-924EBD74C558}"/>
              </a:ext>
            </a:extLst>
          </p:cNvPr>
          <p:cNvSpPr/>
          <p:nvPr/>
        </p:nvSpPr>
        <p:spPr>
          <a:xfrm>
            <a:off x="-1" y="57837"/>
            <a:ext cx="121920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lang="en-US" sz="3600" b="1" dirty="0">
                <a:latin typeface="Calibri" panose="020F0502020204030204" pitchFamily="34" charset="0"/>
                <a:cs typeface="Times New Roman" panose="02020603050405020304" pitchFamily="18" charset="0"/>
              </a:rPr>
              <a:t>TNT-mediated mitochondria transfer from pericytes </a:t>
            </a:r>
          </a:p>
          <a:p>
            <a:pPr lvl="0" algn="ctr"/>
            <a:r>
              <a:rPr lang="en-US" sz="3600" b="1" dirty="0">
                <a:latin typeface="Calibri" panose="020F0502020204030204" pitchFamily="34" charset="0"/>
                <a:cs typeface="Times New Roman" panose="02020603050405020304" pitchFamily="18" charset="0"/>
              </a:rPr>
              <a:t>to OGD/R-Astrocytes </a:t>
            </a:r>
          </a:p>
        </p:txBody>
      </p:sp>
      <p:pic>
        <p:nvPicPr>
          <p:cNvPr id="3" name="3_1_40" descr="3_1_40">
            <a:hlinkClick r:id="" action="ppaction://media"/>
            <a:extLst>
              <a:ext uri="{FF2B5EF4-FFF2-40B4-BE49-F238E27FC236}">
                <a16:creationId xmlns:a16="http://schemas.microsoft.com/office/drawing/2014/main" id="{04C1BF36-C983-0C4D-A699-BDF1CF98F391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6096000" y="2289304"/>
            <a:ext cx="5910470" cy="4432853"/>
          </a:xfrm>
          <a:prstGeom prst="rect">
            <a:avLst/>
          </a:prstGeom>
        </p:spPr>
      </p:pic>
      <p:pic>
        <p:nvPicPr>
          <p:cNvPr id="5" name="8 ii_1_40" descr="8 ii_1_40">
            <a:hlinkClick r:id="" action="ppaction://media"/>
            <a:extLst>
              <a:ext uri="{FF2B5EF4-FFF2-40B4-BE49-F238E27FC236}">
                <a16:creationId xmlns:a16="http://schemas.microsoft.com/office/drawing/2014/main" id="{87ABEC0A-AB59-B44A-A4DE-DFF8B70B7604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53009" y="2289305"/>
            <a:ext cx="5910470" cy="4432853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069FB335-D948-7B49-B7B4-8D0A84415E27}"/>
              </a:ext>
            </a:extLst>
          </p:cNvPr>
          <p:cNvSpPr txBox="1"/>
          <p:nvPr/>
        </p:nvSpPr>
        <p:spPr>
          <a:xfrm>
            <a:off x="-62620" y="4846425"/>
            <a:ext cx="387978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4000" b="1" dirty="0">
                <a:solidFill>
                  <a:schemeClr val="bg1"/>
                </a:solidFill>
              </a:rPr>
              <a:t>OGD/</a:t>
            </a:r>
            <a:r>
              <a:rPr lang="it-IT" sz="4000" b="1" dirty="0" err="1">
                <a:solidFill>
                  <a:schemeClr val="bg1"/>
                </a:solidFill>
              </a:rPr>
              <a:t>R-Astrocyte</a:t>
            </a:r>
            <a:endParaRPr lang="it-IT" sz="4000" b="1" dirty="0">
              <a:solidFill>
                <a:schemeClr val="bg1"/>
              </a:solidFill>
            </a:endParaRP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8587CA44-0E65-A542-8358-03B95E176308}"/>
              </a:ext>
            </a:extLst>
          </p:cNvPr>
          <p:cNvSpPr txBox="1"/>
          <p:nvPr/>
        </p:nvSpPr>
        <p:spPr>
          <a:xfrm>
            <a:off x="3925881" y="5762214"/>
            <a:ext cx="1907061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4000" b="1" dirty="0" err="1">
                <a:solidFill>
                  <a:schemeClr val="bg1"/>
                </a:solidFill>
              </a:rPr>
              <a:t>Pericyte</a:t>
            </a:r>
            <a:endParaRPr lang="it-IT" sz="4000" b="1" dirty="0">
              <a:solidFill>
                <a:schemeClr val="bg1"/>
              </a:solidFill>
            </a:endParaRP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E0768F1B-8C20-F246-AC12-1A3DEF75B458}"/>
              </a:ext>
            </a:extLst>
          </p:cNvPr>
          <p:cNvSpPr txBox="1"/>
          <p:nvPr/>
        </p:nvSpPr>
        <p:spPr>
          <a:xfrm>
            <a:off x="6622115" y="5762214"/>
            <a:ext cx="387978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4000" b="1" dirty="0">
                <a:solidFill>
                  <a:schemeClr val="bg1"/>
                </a:solidFill>
              </a:rPr>
              <a:t>OGD/</a:t>
            </a:r>
            <a:r>
              <a:rPr lang="it-IT" sz="4000" b="1" dirty="0" err="1">
                <a:solidFill>
                  <a:schemeClr val="bg1"/>
                </a:solidFill>
              </a:rPr>
              <a:t>R-Astrocyte</a:t>
            </a:r>
            <a:endParaRPr lang="it-IT" sz="4000" b="1" dirty="0">
              <a:solidFill>
                <a:schemeClr val="bg1"/>
              </a:solidFill>
            </a:endParaRP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F724E59D-2984-6C44-9FDC-D08EBC2DDBE3}"/>
              </a:ext>
            </a:extLst>
          </p:cNvPr>
          <p:cNvSpPr txBox="1"/>
          <p:nvPr/>
        </p:nvSpPr>
        <p:spPr>
          <a:xfrm>
            <a:off x="9758759" y="2643248"/>
            <a:ext cx="1907061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4000" b="1" dirty="0" err="1">
                <a:solidFill>
                  <a:schemeClr val="bg1"/>
                </a:solidFill>
              </a:rPr>
              <a:t>Pericyte</a:t>
            </a:r>
            <a:endParaRPr lang="it-IT" sz="4000" b="1" dirty="0">
              <a:solidFill>
                <a:schemeClr val="bg1"/>
              </a:solidFill>
            </a:endParaRP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CE5C5CA5-08E7-A145-A09D-2170BBFD1182}"/>
              </a:ext>
            </a:extLst>
          </p:cNvPr>
          <p:cNvSpPr txBox="1"/>
          <p:nvPr/>
        </p:nvSpPr>
        <p:spPr>
          <a:xfrm>
            <a:off x="53009" y="2343273"/>
            <a:ext cx="1192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highlight>
                  <a:srgbClr val="FFFF00"/>
                </a:highlight>
              </a:rPr>
              <a:t>Movie </a:t>
            </a:r>
            <a:r>
              <a:rPr lang="it-IT" b="1" dirty="0">
                <a:highlight>
                  <a:srgbClr val="FFFF00"/>
                </a:highlight>
              </a:rPr>
              <a:t>#10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66BEF699-1611-974B-B3ED-3272935D6120}"/>
              </a:ext>
            </a:extLst>
          </p:cNvPr>
          <p:cNvSpPr txBox="1"/>
          <p:nvPr/>
        </p:nvSpPr>
        <p:spPr>
          <a:xfrm>
            <a:off x="6095999" y="2316059"/>
            <a:ext cx="1192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highlight>
                  <a:srgbClr val="FFFF00"/>
                </a:highlight>
              </a:rPr>
              <a:t>Movie </a:t>
            </a:r>
            <a:r>
              <a:rPr lang="it-IT" b="1" dirty="0">
                <a:highlight>
                  <a:srgbClr val="FFFF00"/>
                </a:highlight>
              </a:rPr>
              <a:t>#11</a:t>
            </a:r>
          </a:p>
        </p:txBody>
      </p:sp>
      <p:cxnSp>
        <p:nvCxnSpPr>
          <p:cNvPr id="13" name="Connettore 1 12">
            <a:extLst>
              <a:ext uri="{FF2B5EF4-FFF2-40B4-BE49-F238E27FC236}">
                <a16:creationId xmlns:a16="http://schemas.microsoft.com/office/drawing/2014/main" id="{64608BBB-ABEB-E043-BEC6-C0A642BCD511}"/>
              </a:ext>
            </a:extLst>
          </p:cNvPr>
          <p:cNvCxnSpPr>
            <a:cxnSpLocks/>
          </p:cNvCxnSpPr>
          <p:nvPr/>
        </p:nvCxnSpPr>
        <p:spPr>
          <a:xfrm>
            <a:off x="1447800" y="4131087"/>
            <a:ext cx="3403600" cy="1127497"/>
          </a:xfrm>
          <a:prstGeom prst="line">
            <a:avLst/>
          </a:prstGeom>
          <a:ln w="38100">
            <a:solidFill>
              <a:srgbClr val="FFFF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6F4B3927-5392-BF43-AC38-9E82D7D2D879}"/>
              </a:ext>
            </a:extLst>
          </p:cNvPr>
          <p:cNvSpPr txBox="1"/>
          <p:nvPr/>
        </p:nvSpPr>
        <p:spPr>
          <a:xfrm>
            <a:off x="2371823" y="3971938"/>
            <a:ext cx="7777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b="1" dirty="0">
                <a:solidFill>
                  <a:srgbClr val="FFFF00"/>
                </a:solidFill>
              </a:rPr>
              <a:t>TNT</a:t>
            </a:r>
          </a:p>
        </p:txBody>
      </p:sp>
      <p:cxnSp>
        <p:nvCxnSpPr>
          <p:cNvPr id="17" name="Connettore 1 16">
            <a:extLst>
              <a:ext uri="{FF2B5EF4-FFF2-40B4-BE49-F238E27FC236}">
                <a16:creationId xmlns:a16="http://schemas.microsoft.com/office/drawing/2014/main" id="{369ADB3A-B413-DC4C-AFE5-2393312AE041}"/>
              </a:ext>
            </a:extLst>
          </p:cNvPr>
          <p:cNvCxnSpPr>
            <a:cxnSpLocks/>
          </p:cNvCxnSpPr>
          <p:nvPr/>
        </p:nvCxnSpPr>
        <p:spPr>
          <a:xfrm flipV="1">
            <a:off x="8331200" y="3016463"/>
            <a:ext cx="1358900" cy="1769835"/>
          </a:xfrm>
          <a:prstGeom prst="line">
            <a:avLst/>
          </a:prstGeom>
          <a:ln w="38100">
            <a:solidFill>
              <a:srgbClr val="FFFF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BCAD3CD5-BDEB-4440-B161-428DAD28DFD7}"/>
              </a:ext>
            </a:extLst>
          </p:cNvPr>
          <p:cNvSpPr txBox="1"/>
          <p:nvPr/>
        </p:nvSpPr>
        <p:spPr>
          <a:xfrm>
            <a:off x="7942311" y="4033454"/>
            <a:ext cx="7777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800" b="1" dirty="0">
                <a:solidFill>
                  <a:srgbClr val="FFFF00"/>
                </a:solidFill>
              </a:rPr>
              <a:t>TNT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C32ABD94-620B-B64B-9536-E88E09512FFC}"/>
              </a:ext>
            </a:extLst>
          </p:cNvPr>
          <p:cNvSpPr txBox="1"/>
          <p:nvPr/>
        </p:nvSpPr>
        <p:spPr>
          <a:xfrm>
            <a:off x="1" y="1100372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400" b="1" dirty="0" err="1">
                <a:solidFill>
                  <a:srgbClr val="FF0000"/>
                </a:solidFill>
              </a:rPr>
              <a:t>Pericytes</a:t>
            </a:r>
            <a:r>
              <a:rPr lang="it-IT" sz="2400" b="1" dirty="0">
                <a:solidFill>
                  <a:srgbClr val="FF0000"/>
                </a:solidFill>
              </a:rPr>
              <a:t> </a:t>
            </a:r>
            <a:r>
              <a:rPr lang="it-IT" sz="2400" b="1" dirty="0" err="1">
                <a:solidFill>
                  <a:srgbClr val="FF0000"/>
                </a:solidFill>
              </a:rPr>
              <a:t>mitochondria</a:t>
            </a:r>
            <a:r>
              <a:rPr lang="it-IT" sz="2400" b="1" dirty="0">
                <a:solidFill>
                  <a:srgbClr val="FF0000"/>
                </a:solidFill>
              </a:rPr>
              <a:t>/</a:t>
            </a:r>
            <a:r>
              <a:rPr lang="it-IT" sz="2400" b="1" dirty="0" err="1">
                <a:solidFill>
                  <a:srgbClr val="2646B3"/>
                </a:solidFill>
              </a:rPr>
              <a:t>Astrocytes</a:t>
            </a:r>
            <a:r>
              <a:rPr lang="it-IT" sz="2400" b="1" dirty="0">
                <a:solidFill>
                  <a:srgbClr val="2646B3"/>
                </a:solidFill>
              </a:rPr>
              <a:t> Cell-</a:t>
            </a:r>
            <a:r>
              <a:rPr lang="it-IT" sz="2400" b="1" dirty="0" err="1">
                <a:solidFill>
                  <a:srgbClr val="2646B3"/>
                </a:solidFill>
              </a:rPr>
              <a:t>Mask</a:t>
            </a:r>
            <a:r>
              <a:rPr lang="it-IT" sz="2400" b="1" dirty="0">
                <a:solidFill>
                  <a:srgbClr val="2646B3"/>
                </a:solidFill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13299743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3285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11714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22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2_1_40" descr="2_1_40">
            <a:hlinkClick r:id="" action="ppaction://media"/>
            <a:extLst>
              <a:ext uri="{FF2B5EF4-FFF2-40B4-BE49-F238E27FC236}">
                <a16:creationId xmlns:a16="http://schemas.microsoft.com/office/drawing/2014/main" id="{458A071D-B48A-5B4E-9240-E82D3CF3F564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331306" y="2072643"/>
            <a:ext cx="5548245" cy="4161183"/>
          </a:xfrm>
          <a:prstGeom prst="rect">
            <a:avLst/>
          </a:prstGeom>
        </p:spPr>
      </p:pic>
      <p:sp>
        <p:nvSpPr>
          <p:cNvPr id="3" name="Rettangolo 2">
            <a:extLst>
              <a:ext uri="{FF2B5EF4-FFF2-40B4-BE49-F238E27FC236}">
                <a16:creationId xmlns:a16="http://schemas.microsoft.com/office/drawing/2014/main" id="{6098E2D4-FA3A-404B-971B-B84FBB5C7C7A}"/>
              </a:ext>
            </a:extLst>
          </p:cNvPr>
          <p:cNvSpPr/>
          <p:nvPr/>
        </p:nvSpPr>
        <p:spPr>
          <a:xfrm>
            <a:off x="-1" y="57837"/>
            <a:ext cx="121920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/>
            <a:r>
              <a:rPr lang="en-US" sz="3600" b="1" dirty="0" err="1">
                <a:latin typeface="Calibri" panose="020F0502020204030204" pitchFamily="34" charset="0"/>
                <a:cs typeface="Times New Roman" panose="02020603050405020304" pitchFamily="18" charset="0"/>
              </a:rPr>
              <a:t>CytoD</a:t>
            </a:r>
            <a:r>
              <a:rPr lang="en-US" sz="3600" b="1" dirty="0">
                <a:latin typeface="Calibri" panose="020F0502020204030204" pitchFamily="34" charset="0"/>
                <a:cs typeface="Times New Roman" panose="02020603050405020304" pitchFamily="18" charset="0"/>
              </a:rPr>
              <a:t> prevents TNT formation and TNT-mediated mitochondria transfer to OGD/R-Astrocytes</a:t>
            </a:r>
            <a:endParaRPr lang="it-IT" sz="3600" b="1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12_1_40" descr="12_1_40">
            <a:hlinkClick r:id="" action="ppaction://media"/>
            <a:extLst>
              <a:ext uri="{FF2B5EF4-FFF2-40B4-BE49-F238E27FC236}">
                <a16:creationId xmlns:a16="http://schemas.microsoft.com/office/drawing/2014/main" id="{AD72904D-F8D5-5C44-8698-F1867752E6A0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6096000" y="2072643"/>
            <a:ext cx="5548244" cy="4161183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5E5C753E-3F83-1142-A30B-921DF3697C1A}"/>
              </a:ext>
            </a:extLst>
          </p:cNvPr>
          <p:cNvSpPr txBox="1"/>
          <p:nvPr/>
        </p:nvSpPr>
        <p:spPr>
          <a:xfrm>
            <a:off x="375097" y="5531548"/>
            <a:ext cx="15738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3600" b="1" dirty="0">
                <a:solidFill>
                  <a:srgbClr val="FF0000"/>
                </a:solidFill>
                <a:highlight>
                  <a:srgbClr val="FFFF00"/>
                </a:highlight>
              </a:rPr>
              <a:t>+</a:t>
            </a:r>
            <a:r>
              <a:rPr lang="it-IT" sz="3600" b="1" dirty="0" err="1">
                <a:solidFill>
                  <a:srgbClr val="FF0000"/>
                </a:solidFill>
                <a:highlight>
                  <a:srgbClr val="FFFF00"/>
                </a:highlight>
              </a:rPr>
              <a:t>CytoD</a:t>
            </a:r>
            <a:endParaRPr lang="it-IT" sz="3600" b="1" dirty="0">
              <a:solidFill>
                <a:srgbClr val="FF0000"/>
              </a:solidFill>
              <a:highlight>
                <a:srgbClr val="FFFF00"/>
              </a:highlight>
            </a:endParaRP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55667E50-98F9-0945-AF70-E67AA5E6DE16}"/>
              </a:ext>
            </a:extLst>
          </p:cNvPr>
          <p:cNvSpPr txBox="1"/>
          <p:nvPr/>
        </p:nvSpPr>
        <p:spPr>
          <a:xfrm>
            <a:off x="3127184" y="5174757"/>
            <a:ext cx="1907061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4000" b="1" dirty="0" err="1">
                <a:solidFill>
                  <a:schemeClr val="bg1"/>
                </a:solidFill>
              </a:rPr>
              <a:t>Pericyte</a:t>
            </a:r>
            <a:endParaRPr lang="it-IT" sz="4000" b="1" dirty="0">
              <a:solidFill>
                <a:schemeClr val="bg1"/>
              </a:solidFill>
            </a:endParaRP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3081FEDD-CE97-5740-AA72-84DB7841C1BC}"/>
              </a:ext>
            </a:extLst>
          </p:cNvPr>
          <p:cNvSpPr txBox="1"/>
          <p:nvPr/>
        </p:nvSpPr>
        <p:spPr>
          <a:xfrm>
            <a:off x="547756" y="2349979"/>
            <a:ext cx="387978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4000" b="1" dirty="0">
                <a:solidFill>
                  <a:schemeClr val="bg1"/>
                </a:solidFill>
              </a:rPr>
              <a:t>OGD/</a:t>
            </a:r>
            <a:r>
              <a:rPr lang="it-IT" sz="4000" b="1" dirty="0" err="1">
                <a:solidFill>
                  <a:schemeClr val="bg1"/>
                </a:solidFill>
              </a:rPr>
              <a:t>R-Astrocyte</a:t>
            </a:r>
            <a:endParaRPr lang="it-IT" sz="4000" b="1" dirty="0">
              <a:solidFill>
                <a:schemeClr val="bg1"/>
              </a:solidFill>
            </a:endParaRP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E0C39532-CF08-AC4C-A6B8-88D1610F3207}"/>
              </a:ext>
            </a:extLst>
          </p:cNvPr>
          <p:cNvSpPr txBox="1"/>
          <p:nvPr/>
        </p:nvSpPr>
        <p:spPr>
          <a:xfrm>
            <a:off x="6327584" y="2703922"/>
            <a:ext cx="1907061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4000" b="1" dirty="0" err="1">
                <a:solidFill>
                  <a:schemeClr val="bg1"/>
                </a:solidFill>
              </a:rPr>
              <a:t>Pericyte</a:t>
            </a:r>
            <a:endParaRPr lang="it-IT" sz="4000" b="1" dirty="0">
              <a:solidFill>
                <a:schemeClr val="bg1"/>
              </a:solidFill>
            </a:endParaRP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CBCA6108-7EDA-EC40-B1A4-76622F71F510}"/>
              </a:ext>
            </a:extLst>
          </p:cNvPr>
          <p:cNvSpPr txBox="1"/>
          <p:nvPr/>
        </p:nvSpPr>
        <p:spPr>
          <a:xfrm>
            <a:off x="7764464" y="5202774"/>
            <a:ext cx="387978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4000" b="1" dirty="0">
                <a:solidFill>
                  <a:schemeClr val="bg1"/>
                </a:solidFill>
              </a:rPr>
              <a:t>OGD/</a:t>
            </a:r>
            <a:r>
              <a:rPr lang="it-IT" sz="4000" b="1" dirty="0" err="1">
                <a:solidFill>
                  <a:schemeClr val="bg1"/>
                </a:solidFill>
              </a:rPr>
              <a:t>R-Astrocyte</a:t>
            </a:r>
            <a:endParaRPr lang="it-IT" sz="4000" b="1" dirty="0">
              <a:solidFill>
                <a:schemeClr val="bg1"/>
              </a:solidFill>
            </a:endParaRP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F8019234-39E3-5B4B-8456-19BA7550D011}"/>
              </a:ext>
            </a:extLst>
          </p:cNvPr>
          <p:cNvSpPr txBox="1"/>
          <p:nvPr/>
        </p:nvSpPr>
        <p:spPr>
          <a:xfrm>
            <a:off x="304802" y="2072643"/>
            <a:ext cx="1192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highlight>
                  <a:srgbClr val="FFFF00"/>
                </a:highlight>
              </a:rPr>
              <a:t>Movie </a:t>
            </a:r>
            <a:r>
              <a:rPr lang="it-IT" b="1" dirty="0">
                <a:highlight>
                  <a:srgbClr val="FFFF00"/>
                </a:highlight>
              </a:rPr>
              <a:t>#12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CC29DE42-092C-274B-834B-48E38ADC6CA4}"/>
              </a:ext>
            </a:extLst>
          </p:cNvPr>
          <p:cNvSpPr txBox="1"/>
          <p:nvPr/>
        </p:nvSpPr>
        <p:spPr>
          <a:xfrm>
            <a:off x="6095999" y="2072643"/>
            <a:ext cx="1192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highlight>
                  <a:srgbClr val="FFFF00"/>
                </a:highlight>
              </a:rPr>
              <a:t>Movie </a:t>
            </a:r>
            <a:r>
              <a:rPr lang="it-IT" b="1" dirty="0">
                <a:highlight>
                  <a:srgbClr val="FFFF00"/>
                </a:highlight>
              </a:rPr>
              <a:t>#13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F4BAE730-EFC3-A14B-87F4-01AFC4BF8DC8}"/>
              </a:ext>
            </a:extLst>
          </p:cNvPr>
          <p:cNvSpPr txBox="1"/>
          <p:nvPr/>
        </p:nvSpPr>
        <p:spPr>
          <a:xfrm>
            <a:off x="6064928" y="5587495"/>
            <a:ext cx="15738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3600" b="1" dirty="0">
                <a:solidFill>
                  <a:srgbClr val="FF0000"/>
                </a:solidFill>
                <a:highlight>
                  <a:srgbClr val="FFFF00"/>
                </a:highlight>
              </a:rPr>
              <a:t>+</a:t>
            </a:r>
            <a:r>
              <a:rPr lang="it-IT" sz="3600" b="1" dirty="0" err="1">
                <a:solidFill>
                  <a:srgbClr val="FF0000"/>
                </a:solidFill>
                <a:highlight>
                  <a:srgbClr val="FFFF00"/>
                </a:highlight>
              </a:rPr>
              <a:t>CytoD</a:t>
            </a:r>
            <a:endParaRPr lang="it-IT" sz="3600" b="1" dirty="0">
              <a:solidFill>
                <a:srgbClr val="FF0000"/>
              </a:solidFill>
              <a:highlight>
                <a:srgbClr val="FFFF00"/>
              </a:highlight>
            </a:endParaRP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FA96BD70-AF09-EE4C-8E41-F51256C94114}"/>
              </a:ext>
            </a:extLst>
          </p:cNvPr>
          <p:cNvSpPr txBox="1"/>
          <p:nvPr/>
        </p:nvSpPr>
        <p:spPr>
          <a:xfrm>
            <a:off x="1" y="1100372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400" b="1" dirty="0" err="1">
                <a:solidFill>
                  <a:srgbClr val="FF0000"/>
                </a:solidFill>
              </a:rPr>
              <a:t>Pericytes</a:t>
            </a:r>
            <a:r>
              <a:rPr lang="it-IT" sz="2400" b="1" dirty="0">
                <a:solidFill>
                  <a:srgbClr val="FF0000"/>
                </a:solidFill>
              </a:rPr>
              <a:t> </a:t>
            </a:r>
            <a:r>
              <a:rPr lang="it-IT" sz="2400" b="1" dirty="0" err="1">
                <a:solidFill>
                  <a:srgbClr val="FF0000"/>
                </a:solidFill>
              </a:rPr>
              <a:t>mitochondria</a:t>
            </a:r>
            <a:r>
              <a:rPr lang="it-IT" sz="2400" b="1" dirty="0">
                <a:solidFill>
                  <a:srgbClr val="FF0000"/>
                </a:solidFill>
              </a:rPr>
              <a:t>/</a:t>
            </a:r>
            <a:r>
              <a:rPr lang="it-IT" sz="2400" b="1" dirty="0" err="1">
                <a:solidFill>
                  <a:srgbClr val="2646B3"/>
                </a:solidFill>
              </a:rPr>
              <a:t>Astrocytes</a:t>
            </a:r>
            <a:r>
              <a:rPr lang="it-IT" sz="2400" b="1" dirty="0">
                <a:solidFill>
                  <a:srgbClr val="2646B3"/>
                </a:solidFill>
              </a:rPr>
              <a:t> Cell-</a:t>
            </a:r>
            <a:r>
              <a:rPr lang="it-IT" sz="2400" b="1" dirty="0" err="1">
                <a:solidFill>
                  <a:srgbClr val="2646B3"/>
                </a:solidFill>
              </a:rPr>
              <a:t>Mask</a:t>
            </a:r>
            <a:r>
              <a:rPr lang="it-IT" sz="2400" b="1" dirty="0">
                <a:solidFill>
                  <a:srgbClr val="2646B3"/>
                </a:solidFill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54854816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714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3428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1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1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9" fill="hold">
                      <p:stCondLst>
                        <p:cond delay="0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A6243615CEA0024BBCBBB65F1F6BD069" ma:contentTypeVersion="14" ma:contentTypeDescription="Creare un nuovo documento." ma:contentTypeScope="" ma:versionID="a625b094cccbf6977b64d2084137dc60">
  <xsd:schema xmlns:xsd="http://www.w3.org/2001/XMLSchema" xmlns:xs="http://www.w3.org/2001/XMLSchema" xmlns:p="http://schemas.microsoft.com/office/2006/metadata/properties" xmlns:ns3="db5dbd57-83cc-4b67-bfb6-19657461690e" xmlns:ns4="acfa8718-ee53-414b-ab15-01c7f90c0029" targetNamespace="http://schemas.microsoft.com/office/2006/metadata/properties" ma:root="true" ma:fieldsID="99e8c7a4788a4550be9a14547ed8cbb5" ns3:_="" ns4:_="">
    <xsd:import namespace="db5dbd57-83cc-4b67-bfb6-19657461690e"/>
    <xsd:import namespace="acfa8718-ee53-414b-ab15-01c7f90c0029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AutoTags" minOccurs="0"/>
                <xsd:element ref="ns4:MediaServiceGenerationTime" minOccurs="0"/>
                <xsd:element ref="ns4:MediaServiceEventHashCode" minOccurs="0"/>
                <xsd:element ref="ns4:MediaServiceOCR" minOccurs="0"/>
                <xsd:element ref="ns4:MediaServiceDateTaken" minOccurs="0"/>
                <xsd:element ref="ns4:MediaServiceLocation" minOccurs="0"/>
                <xsd:element ref="ns4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b5dbd57-83cc-4b67-bfb6-19657461690e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Condivis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Condiviso con dettagli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Hash suggerimento condivisione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cfa8718-ee53-414b-ab15-01c7f90c002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E55DBC39-E6A1-4807-91D9-8C8C94949A0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b5dbd57-83cc-4b67-bfb6-19657461690e"/>
    <ds:schemaRef ds:uri="acfa8718-ee53-414b-ab15-01c7f90c002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0D27EF20-9B37-4D9C-B6E6-15472DA0D4D7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6A5E5DC4-A623-4D1E-9142-4ED5D01DE60B}">
  <ds:schemaRefs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db5dbd57-83cc-4b67-bfb6-19657461690e"/>
    <ds:schemaRef ds:uri="acfa8718-ee53-414b-ab15-01c7f90c0029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3</Words>
  <Application>Microsoft Office PowerPoint</Application>
  <PresentationFormat>Widescreen</PresentationFormat>
  <Paragraphs>32</Paragraphs>
  <Slides>3</Slides>
  <Notes>0</Notes>
  <HiddenSlides>0</HiddenSlides>
  <MMClips>4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lentina Castagnola</dc:creator>
  <cp:lastModifiedBy>Valentina Castagnola</cp:lastModifiedBy>
  <cp:revision>1</cp:revision>
  <dcterms:created xsi:type="dcterms:W3CDTF">2022-03-02T16:02:45Z</dcterms:created>
  <dcterms:modified xsi:type="dcterms:W3CDTF">2022-03-02T16:02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6243615CEA0024BBCBBB65F1F6BD069</vt:lpwstr>
  </property>
</Properties>
</file>